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40" d="100"/>
          <a:sy n="140" d="100"/>
        </p:scale>
        <p:origin x="-112" y="-4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1192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424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578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929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544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070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899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197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903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024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425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33073-7DB9-4A45-A034-AD344C5D8AE2}" type="datetimeFigureOut">
              <a:rPr lang="en-US" smtClean="0"/>
              <a:t>11/1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5B38B-BEE6-436F-BB84-E21A648C8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685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9329391"/>
              </p:ext>
            </p:extLst>
          </p:nvPr>
        </p:nvGraphicFramePr>
        <p:xfrm>
          <a:off x="457200" y="685800"/>
          <a:ext cx="8296272" cy="3398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66800"/>
                <a:gridCol w="838200"/>
                <a:gridCol w="1066800"/>
                <a:gridCol w="1066800"/>
                <a:gridCol w="990600"/>
                <a:gridCol w="1066800"/>
                <a:gridCol w="1143000"/>
                <a:gridCol w="1057272"/>
              </a:tblGrid>
              <a:tr h="32133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BTH_sR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BTH_sR1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BTH_sR19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BTH_sR36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BTH_sR39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BTH_II2030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BTH-5S </a:t>
                      </a:r>
                      <a:r>
                        <a:rPr lang="en-US" sz="1200" dirty="0" err="1" smtClean="0"/>
                        <a:t>rRNA</a:t>
                      </a:r>
                      <a:endParaRPr lang="en-US" sz="1200" dirty="0"/>
                    </a:p>
                  </a:txBody>
                  <a:tcPr/>
                </a:tc>
              </a:tr>
              <a:tr h="374392">
                <a:tc>
                  <a:txBody>
                    <a:bodyPr/>
                    <a:lstStyle/>
                    <a:p>
                      <a:r>
                        <a:rPr lang="en-US" sz="1200" dirty="0" err="1" smtClean="0"/>
                        <a:t>qPCR</a:t>
                      </a:r>
                      <a:r>
                        <a:rPr lang="en-US" sz="1200" dirty="0" smtClean="0"/>
                        <a:t> FW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latin typeface="+mn-lt"/>
                        </a:rPr>
                        <a:t>GCTACGGGGAACAATAAAA</a:t>
                      </a:r>
                      <a:endParaRPr lang="en-US" sz="1000" b="0" i="0" u="none" strike="noStrike" dirty="0"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CTCCGATACCGATGCGGTCCGA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ACGCCCGATTCTCGCAGGGTTTG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CAGGAACCGTCGTGGACAGTAGCAG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latin typeface="+mn-lt"/>
                        </a:rPr>
                        <a:t>GTCTAGACCCCTTCGTGCA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GACCGAACCTATGCGCTCTA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GCCTGATGACCATAGCGAGT</a:t>
                      </a:r>
                      <a:endParaRPr lang="en-US" sz="1000" dirty="0"/>
                    </a:p>
                  </a:txBody>
                  <a:tcPr/>
                </a:tc>
              </a:tr>
              <a:tr h="374392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/>
                        <a:t>qPCR</a:t>
                      </a:r>
                      <a:r>
                        <a:rPr lang="en-US" sz="1200" dirty="0" smtClean="0"/>
                        <a:t> R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latin typeface="+mn-lt"/>
                        </a:rPr>
                        <a:t>GTGGCTTGTTGTGGTGATT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GCCACGTTAACCAAGCGTTCA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TTCAGATC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GAGCGCCAGCACGAACGCCAT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TACATACTCGCGCGACACTTTAG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latin typeface="+mn-lt"/>
                        </a:rPr>
                        <a:t>AAAAAGCGGCTTGGCTT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CTTCGTCAGGATCAGCTTGC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TACTTTCACACGGGCAATC</a:t>
                      </a:r>
                      <a:endParaRPr lang="en-US" sz="1000" dirty="0"/>
                    </a:p>
                  </a:txBody>
                  <a:tcPr/>
                </a:tc>
              </a:tr>
              <a:tr h="374392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RACE1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ATCACCACAACAAGCCACCATG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GCTCCGAACGGTACTTATACCGT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CCAGTGATG CGGCCGACGAA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GCTTCGCCTGAACGCCTGCC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ACATATTCAAGCAGCCGTTGCAGCA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N/A</a:t>
                      </a:r>
                    </a:p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N/A</a:t>
                      </a:r>
                    </a:p>
                    <a:p>
                      <a:endParaRPr lang="en-US" sz="1000" dirty="0"/>
                    </a:p>
                  </a:txBody>
                  <a:tcPr/>
                </a:tc>
              </a:tr>
              <a:tr h="374392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RACE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TGGCCCCGTCGTGCATGC 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CACGTCGAAACAGGGCCTGCAC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CCTCGCCTCTTTCGTCGTTTTG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GGCGTGCGGACGTTGTGCT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TTGCACGAAGGGGTCTAGACTC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N/A</a:t>
                      </a:r>
                    </a:p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N/A</a:t>
                      </a:r>
                    </a:p>
                    <a:p>
                      <a:endParaRPr lang="en-US" sz="1000" dirty="0"/>
                    </a:p>
                  </a:txBody>
                  <a:tcPr/>
                </a:tc>
              </a:tr>
              <a:tr h="56388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5’Biosg prob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000" dirty="0" smtClean="0"/>
                        <a:t>CCCGCGCTGTTTTTATTGTTCC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ATG CCG CTC ATT GGG ACG CCA 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TTCGTCGGCCGCATCACTGGCCTCGCC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N/A</a:t>
                      </a:r>
                    </a:p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GTTTGCACGAAGGGGTCTAGACTCGCG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CCGATTCGGCCG GCGTCGTCA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TCA CGG TCC TGT TCG GGA TGG GAA GGG</a:t>
                      </a:r>
                      <a:endParaRPr lang="en-US" sz="1000" dirty="0"/>
                    </a:p>
                  </a:txBody>
                  <a:tcPr/>
                </a:tc>
              </a:tr>
              <a:tr h="374392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NB</a:t>
                      </a:r>
                      <a:r>
                        <a:rPr lang="en-US" sz="1200" baseline="0" dirty="0" smtClean="0"/>
                        <a:t> annealing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42°C</a:t>
                      </a:r>
                    </a:p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58°C</a:t>
                      </a:r>
                    </a:p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65°C</a:t>
                      </a:r>
                    </a:p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55°C</a:t>
                      </a:r>
                    </a:p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55°C</a:t>
                      </a:r>
                    </a:p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58°C</a:t>
                      </a:r>
                    </a:p>
                    <a:p>
                      <a:endParaRPr lang="en-US" sz="1000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0786868"/>
              </p:ext>
            </p:extLst>
          </p:nvPr>
        </p:nvGraphicFramePr>
        <p:xfrm>
          <a:off x="457200" y="4114800"/>
          <a:ext cx="3657601" cy="254764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66800"/>
                <a:gridCol w="1219199"/>
                <a:gridCol w="1371602"/>
              </a:tblGrid>
              <a:tr h="363497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BTH_I1527/SLT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BTH_I2095</a:t>
                      </a:r>
                      <a:endParaRPr lang="en-US" sz="1200" dirty="0"/>
                    </a:p>
                  </a:txBody>
                  <a:tcPr/>
                </a:tc>
              </a:tr>
              <a:tr h="53777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/>
                        <a:t>qPCR</a:t>
                      </a:r>
                      <a:r>
                        <a:rPr lang="en-US" sz="1200" dirty="0" smtClean="0"/>
                        <a:t> FW</a:t>
                      </a:r>
                    </a:p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GGTGCATTCGGACAAGTTC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GCCGTTCCGCCCGATCTCGA</a:t>
                      </a:r>
                      <a:endParaRPr lang="en-US" sz="1000" dirty="0"/>
                    </a:p>
                  </a:txBody>
                  <a:tcPr/>
                </a:tc>
              </a:tr>
              <a:tr h="448147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/>
                        <a:t>qPCR</a:t>
                      </a:r>
                      <a:r>
                        <a:rPr lang="en-US" sz="1200" dirty="0" smtClean="0"/>
                        <a:t> RV</a:t>
                      </a:r>
                    </a:p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0" i="0" u="none" strike="noStrike" kern="1200" baseline="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GACGCATAGATCGACACCT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TCAACGCTTGTAGAGTTCGCGCA</a:t>
                      </a:r>
                      <a:endParaRPr lang="en-US" sz="1000" dirty="0"/>
                    </a:p>
                  </a:txBody>
                  <a:tcPr/>
                </a:tc>
              </a:tr>
              <a:tr h="627405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5’Biosg probe</a:t>
                      </a:r>
                    </a:p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TCACGTCGTCCTGTTGCGGCGCCTT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GCGGCGCTGTTCGAGATCGGG</a:t>
                      </a:r>
                      <a:endParaRPr lang="en-US" sz="1000" dirty="0"/>
                    </a:p>
                  </a:txBody>
                  <a:tcPr/>
                </a:tc>
              </a:tr>
              <a:tr h="537776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NB</a:t>
                      </a:r>
                      <a:r>
                        <a:rPr lang="en-US" sz="1200" baseline="0" dirty="0" smtClean="0"/>
                        <a:t> annealing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2°C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58°C</a:t>
                      </a:r>
                    </a:p>
                    <a:p>
                      <a:endParaRPr lang="en-US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5105400" y="4572000"/>
            <a:ext cx="3570208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W, forward primer;</a:t>
            </a:r>
          </a:p>
          <a:p>
            <a:r>
              <a:rPr lang="en-US" sz="1200" dirty="0" smtClean="0"/>
              <a:t>RV, reverse primer;</a:t>
            </a:r>
          </a:p>
          <a:p>
            <a:r>
              <a:rPr lang="en-US" sz="1200" dirty="0" smtClean="0"/>
              <a:t>RACE1-2, primers for rapid amplification of </a:t>
            </a:r>
            <a:r>
              <a:rPr lang="en-US" sz="1200" dirty="0" err="1" smtClean="0"/>
              <a:t>cDNA</a:t>
            </a:r>
            <a:r>
              <a:rPr lang="en-US" sz="1200" dirty="0" smtClean="0"/>
              <a:t> ends</a:t>
            </a:r>
          </a:p>
          <a:p>
            <a:r>
              <a:rPr lang="en-US" sz="1200" dirty="0" smtClean="0"/>
              <a:t>5’Biosg probe for Northern blot (NB)</a:t>
            </a:r>
          </a:p>
          <a:p>
            <a:endParaRPr lang="en-US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457200" y="228600"/>
            <a:ext cx="1221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dditional </a:t>
            </a:r>
            <a:r>
              <a:rPr lang="en-US" sz="1200" b="1" smtClean="0"/>
              <a:t>File </a:t>
            </a:r>
            <a:r>
              <a:rPr lang="en-US" sz="1200" b="1" smtClean="0"/>
              <a:t>7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139057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6</TotalTime>
  <Words>162</Words>
  <Application>Microsoft Macintosh PowerPoint</Application>
  <PresentationFormat>On-screen Show (4:3)</PresentationFormat>
  <Paragraphs>7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os Alamos National Laborator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eva-Viteva, Sofiya N</dc:creator>
  <cp:lastModifiedBy>171437</cp:lastModifiedBy>
  <cp:revision>12</cp:revision>
  <dcterms:created xsi:type="dcterms:W3CDTF">2013-10-09T22:18:25Z</dcterms:created>
  <dcterms:modified xsi:type="dcterms:W3CDTF">2013-11-16T01:27:40Z</dcterms:modified>
</cp:coreProperties>
</file>